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1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5" r:id="rId9"/>
    <p:sldId id="266" r:id="rId10"/>
    <p:sldId id="267" r:id="rId11"/>
    <p:sldId id="268" r:id="rId12"/>
    <p:sldId id="269" r:id="rId13"/>
    <p:sldId id="270" r:id="rId14"/>
    <p:sldId id="263" r:id="rId15"/>
    <p:sldId id="264" r:id="rId16"/>
    <p:sldId id="271" r:id="rId17"/>
    <p:sldId id="272" r:id="rId18"/>
    <p:sldId id="273" r:id="rId19"/>
    <p:sldId id="274" r:id="rId2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/>
    <p:restoredTop sz="94684"/>
  </p:normalViewPr>
  <p:slideViewPr>
    <p:cSldViewPr snapToGrid="0">
      <p:cViewPr varScale="1">
        <p:scale>
          <a:sx n="98" d="100"/>
          <a:sy n="98" d="100"/>
        </p:scale>
        <p:origin x="200" y="4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53C58B-F72F-6C48-8A3D-D4437EEC9CD3}" type="datetimeFigureOut">
              <a:rPr lang="en-US" smtClean="0"/>
              <a:t>12/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864291-A1C7-BC40-9C2E-76632BA52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0951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864291-A1C7-BC40-9C2E-76632BA52CD6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5540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B069305-8816-714B-4303-FF8E8623A64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B633BDC9-C285-02B6-A47D-A57943271BA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94C108A2-DD53-D45E-01A9-B3C50E79F93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BB92D31-888D-A4F6-AFD5-1847C961155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864291-A1C7-BC40-9C2E-76632BA52CD6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5423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DF291C6-BED9-DAA4-18FF-5038A956842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A584A1AF-5F18-D0A9-C3F2-7AF0659A472D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5651927A-11AE-D7DF-578C-53A30E82D66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F33276F-96FE-DB3B-FBAC-B2961DF610E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864291-A1C7-BC40-9C2E-76632BA52CD6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69842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8E5707A-9978-C47B-FE86-B767B1F5902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2E994AE0-A59D-F20A-256C-FAD50D4478C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BA45509B-6C24-75A3-461E-02F1A309770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6CD75E7-D169-C825-5389-112BF34FDE0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864291-A1C7-BC40-9C2E-76632BA52CD6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77883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EB515BC-8B62-34C0-EA1C-67BE3579033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A1838581-EEF9-AD0E-BA69-D8BE3898A82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80DDF3FE-40DD-984F-E86A-7544C4E4904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28BD0A3-8372-8CE8-0EE1-7DA665C4DF9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864291-A1C7-BC40-9C2E-76632BA52CD6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613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7E0381-EBC9-E364-205F-0041E3EED5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A7173DE-EF4F-FC0E-6659-7482641D1D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9FC3B7-21CB-9A6B-5B4D-838454180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31776F-6704-C446-961D-3EC4F250B676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211C99-7F1F-42D0-9226-EF23407B1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E021E1-E057-1C33-2FA8-407C8AB35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82B47-12B4-EF46-9BCF-5B6A175A8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9672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C8EF94-1C2F-2D87-E8EA-CC02E79576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BEA45D-863C-646B-849A-A651A00D4C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0BA59-6979-7AE5-C839-DF174C96AB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31776F-6704-C446-961D-3EC4F250B676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71669E-56D8-2CF4-367F-B3C83CA5C5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510E00-54F4-F9B4-9787-9A731A9B5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82B47-12B4-EF46-9BCF-5B6A175A8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644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6E744BA-BFF8-8354-60C0-8221ADB566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242561-BC42-836B-5D75-89B86702B4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348011-DFAF-8562-D4E3-A57E9F7DC8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31776F-6704-C446-961D-3EC4F250B676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03FDC4-4D77-62EA-EA9C-A7D11D209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75933-B56C-0810-98E2-F2B00C30C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82B47-12B4-EF46-9BCF-5B6A175A8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280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F86257-9E5C-0DEF-A427-241436711D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B5897A-10DB-B2B0-DCF1-064E47B33E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F22B7C-0BB8-4B2D-10D8-3D4D245A0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31776F-6704-C446-961D-3EC4F250B676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88BB45-D4F4-5048-1244-9371ECBFF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304AB3-4593-CFEC-5742-91E33A391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82B47-12B4-EF46-9BCF-5B6A175A8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457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F56176-5F57-8670-8130-03D09F0C53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6B64CC-6967-070B-7BEA-5235DE5DC9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08C417-69E0-6B6A-2997-DCE1B9357D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31776F-6704-C446-961D-3EC4F250B676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C7476E-DBC3-376B-D796-2EC2C3B58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70346E-A615-17AA-B78F-9B9F7AE2C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82B47-12B4-EF46-9BCF-5B6A175A8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564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A2F45B-C2E2-8C31-A9E2-592F2AB193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29A888-8FA2-9361-9682-3D64CF96B5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40A198-7803-D3C9-E312-EF3D666BF0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56E00F-BA02-2197-54AF-3F8D0EA4EF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31776F-6704-C446-961D-3EC4F250B676}" type="datetimeFigureOut">
              <a:rPr lang="en-US" smtClean="0"/>
              <a:t>12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16B4D4-F98E-7B23-559F-24678A736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E5CBB9-2D2A-F081-3EBD-0D7E2F324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82B47-12B4-EF46-9BCF-5B6A175A8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22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59E0D5-1A2C-6316-6C77-58A95D255E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50F46F-B060-F239-7EE4-858E5C864B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F59E6F-85D8-5C7D-6155-4D1CB801D0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6C9942D-3D6D-CA2B-2F60-7E7BFE5C03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C06F19C-2872-9083-8AF6-7F214AE24F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AA6AE73-0532-01C3-05E9-6A8562372D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31776F-6704-C446-961D-3EC4F250B676}" type="datetimeFigureOut">
              <a:rPr lang="en-US" smtClean="0"/>
              <a:t>12/1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9D5A6DA-C8EB-51F9-E011-80FF398FC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5053E0D-F389-4800-E800-E4618FFD1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82B47-12B4-EF46-9BCF-5B6A175A8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286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997FD0-73BA-CF58-E082-5D0C10F932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5FF9B79-DCCF-2166-6AA2-0D0A566DE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31776F-6704-C446-961D-3EC4F250B676}" type="datetimeFigureOut">
              <a:rPr lang="en-US" smtClean="0"/>
              <a:t>12/1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30369FB-BD0A-88BD-67BF-88DABCFDC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F183015-E9E7-7776-6AD3-63D941B34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82B47-12B4-EF46-9BCF-5B6A175A8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487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0B3573A-D367-9599-B5E3-5B77D55A88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31776F-6704-C446-961D-3EC4F250B676}" type="datetimeFigureOut">
              <a:rPr lang="en-US" smtClean="0"/>
              <a:t>12/1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7DF0244-5E5D-11D2-235A-5CE862BD11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DCC4BEF-6C92-CBE8-DE5B-0818B15BA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82B47-12B4-EF46-9BCF-5B6A175A8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985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AB4663-34FB-58A9-48BB-18A9DC1CFC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873F72-046B-479B-D463-67E5AED06A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F12D1D-FB37-B5C1-40F2-CA01AEDDA4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4463E8-F70B-EC4E-7D4C-7ED703642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31776F-6704-C446-961D-3EC4F250B676}" type="datetimeFigureOut">
              <a:rPr lang="en-US" smtClean="0"/>
              <a:t>12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FD1B3C-625E-BE62-C144-0EFDB316A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80A9CB-ACC6-C569-8EF4-94B060BFE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82B47-12B4-EF46-9BCF-5B6A175A8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07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6C3807-6911-F3DC-A976-DFB721CAEF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97EDA4-6629-F9F0-6630-602A5E7036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4C26AB-5994-D51D-EF8A-4AAF271712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6373F3-6CA0-E895-097D-BE0DCC4BB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31776F-6704-C446-961D-3EC4F250B676}" type="datetimeFigureOut">
              <a:rPr lang="en-US" smtClean="0"/>
              <a:t>12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606396-F2BC-C1C0-A514-EF914432C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9BE7A9-9DFF-AE2C-EE13-36BA1C1CD0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82B47-12B4-EF46-9BCF-5B6A175A8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61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FA9477-A96C-D99B-CD36-AEBAB47628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EBEF16-5AD4-1032-DA8A-FB1C644A0A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21D44D-919D-4258-2C56-0351E00BD5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F31776F-6704-C446-961D-3EC4F250B676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26B980-96F8-2423-64EC-35ACA231E8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1A653F-4EF0-192B-4CFB-5C4F120DB0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8082B47-12B4-EF46-9BCF-5B6A175A85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397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george.shields@furman.edu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7" Type="http://schemas.openxmlformats.org/officeDocument/2006/relationships/image" Target="../media/image3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png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0920BF96-3A22-8B17-B6FB-8EDF2C2B75A7}"/>
              </a:ext>
            </a:extLst>
          </p:cNvPr>
          <p:cNvSpPr txBox="1"/>
          <p:nvPr/>
        </p:nvSpPr>
        <p:spPr>
          <a:xfrm>
            <a:off x="470263" y="457199"/>
            <a:ext cx="11220994" cy="44012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>
              <a:buNone/>
            </a:pPr>
            <a:r>
              <a:rPr lang="en-US" sz="2800" b="1" dirty="0"/>
              <a:t>The Hydration of Trifluoroacetic</a:t>
            </a:r>
            <a:r>
              <a:rPr lang="en-US" sz="2800" dirty="0"/>
              <a:t> </a:t>
            </a:r>
            <a:r>
              <a:rPr lang="en-US" sz="2800" b="1" dirty="0"/>
              <a:t> Acid from 0 K to 298 K</a:t>
            </a:r>
            <a:endParaRPr lang="en-US" sz="2800" dirty="0"/>
          </a:p>
          <a:p>
            <a:pPr marL="0" indent="0">
              <a:buNone/>
            </a:pPr>
            <a:r>
              <a:rPr lang="en-US" sz="2800" dirty="0"/>
              <a:t>Walker J. Smith, Caroline S. Glick, George C. Shields*</a:t>
            </a:r>
          </a:p>
          <a:p>
            <a:pPr marL="0" indent="0">
              <a:buNone/>
            </a:pPr>
            <a:r>
              <a:rPr lang="en-US" sz="2800" dirty="0"/>
              <a:t>Furman University, Department of Chemistry, 3300 Poinsett Hwy, Greenville, SC 29613, USA</a:t>
            </a:r>
          </a:p>
          <a:p>
            <a:pPr marL="0" indent="0">
              <a:buNone/>
            </a:pPr>
            <a:r>
              <a:rPr lang="en-US" sz="2800" dirty="0"/>
              <a:t>Email: </a:t>
            </a:r>
            <a:r>
              <a:rPr lang="en-US" sz="2800" u="sng" dirty="0">
                <a:hlinkClick r:id="rId2"/>
              </a:rPr>
              <a:t>george.shields@furman.edu</a:t>
            </a:r>
            <a:r>
              <a:rPr lang="en-US" sz="2800" dirty="0"/>
              <a:t>	</a:t>
            </a:r>
          </a:p>
          <a:p>
            <a:pPr marL="0" indent="0">
              <a:buNone/>
            </a:pPr>
            <a:endParaRPr lang="en-US" sz="2800" dirty="0"/>
          </a:p>
          <a:p>
            <a:pPr marL="0" indent="0">
              <a:buNone/>
            </a:pPr>
            <a:endParaRPr lang="en-US" sz="2800" dirty="0"/>
          </a:p>
          <a:p>
            <a:pPr marL="0" indent="0">
              <a:buNone/>
            </a:pPr>
            <a:endParaRPr lang="en-US" sz="2800" dirty="0"/>
          </a:p>
          <a:p>
            <a:pPr marL="0" indent="0">
              <a:buNone/>
            </a:pPr>
            <a:r>
              <a:rPr lang="en-US" sz="2800" dirty="0"/>
              <a:t>Lowest energy structures at 0 K according to DLPNO-CCSD(T)/haug-cc-pV5Z//</a:t>
            </a:r>
            <a:r>
              <a:rPr lang="en-US" sz="2800" dirty="0">
                <a:sym typeface="Symbol" pitchFamily="2" charset="2"/>
              </a:rPr>
              <a:t></a:t>
            </a:r>
            <a:r>
              <a:rPr lang="en-US" sz="2800" dirty="0"/>
              <a:t>B97X-D/6-31++G**.</a:t>
            </a:r>
          </a:p>
        </p:txBody>
      </p:sp>
    </p:spTree>
    <p:extLst>
      <p:ext uri="{BB962C8B-B14F-4D97-AF65-F5344CB8AC3E}">
        <p14:creationId xmlns:p14="http://schemas.microsoft.com/office/powerpoint/2010/main" val="3084735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70AE1D4-C42B-42ED-9976-5B2E99E6AF0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molecular structures&#10;&#10;AI-generated content may be incorrect.">
            <a:extLst>
              <a:ext uri="{FF2B5EF4-FFF2-40B4-BE49-F238E27FC236}">
                <a16:creationId xmlns:a16="http://schemas.microsoft.com/office/drawing/2014/main" id="{628CFABF-7B1A-ED1C-DC94-6CC739B993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320134"/>
            <a:ext cx="11932547" cy="6303687"/>
          </a:xfrm>
          <a:prstGeom prst="rect">
            <a:avLst/>
          </a:prstGeom>
        </p:spPr>
      </p:pic>
      <p:sp>
        <p:nvSpPr>
          <p:cNvPr id="11" name="Title 1">
            <a:extLst>
              <a:ext uri="{FF2B5EF4-FFF2-40B4-BE49-F238E27FC236}">
                <a16:creationId xmlns:a16="http://schemas.microsoft.com/office/drawing/2014/main" id="{B721E4E0-9F5D-C864-C4E6-4F2FA844D004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5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36D88C3-4E92-1C4B-D375-4FBEAAA9FB52}"/>
              </a:ext>
            </a:extLst>
          </p:cNvPr>
          <p:cNvSpPr txBox="1"/>
          <p:nvPr/>
        </p:nvSpPr>
        <p:spPr>
          <a:xfrm>
            <a:off x="1200671" y="3118533"/>
            <a:ext cx="25933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151-9757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47 kcal/mo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5A7E989-6D76-86DE-5047-6C1EF05BA4C7}"/>
              </a:ext>
            </a:extLst>
          </p:cNvPr>
          <p:cNvSpPr txBox="1"/>
          <p:nvPr/>
        </p:nvSpPr>
        <p:spPr>
          <a:xfrm>
            <a:off x="4885592" y="3118530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527-18848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48 kcal/m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8DA058B-52C0-AFA4-4BAA-A228B59A980A}"/>
              </a:ext>
            </a:extLst>
          </p:cNvPr>
          <p:cNvSpPr txBox="1"/>
          <p:nvPr/>
        </p:nvSpPr>
        <p:spPr>
          <a:xfrm>
            <a:off x="7805252" y="3118531"/>
            <a:ext cx="24534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904-707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56 kcal/mo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3850BCE-58CC-A6FB-3574-8661D1318147}"/>
              </a:ext>
            </a:extLst>
          </p:cNvPr>
          <p:cNvSpPr txBox="1"/>
          <p:nvPr/>
        </p:nvSpPr>
        <p:spPr>
          <a:xfrm>
            <a:off x="1200671" y="6132903"/>
            <a:ext cx="25321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225-15722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56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24E14F2-156B-888A-77E2-4143FE1D5B9D}"/>
              </a:ext>
            </a:extLst>
          </p:cNvPr>
          <p:cNvSpPr txBox="1"/>
          <p:nvPr/>
        </p:nvSpPr>
        <p:spPr>
          <a:xfrm>
            <a:off x="4885592" y="6132900"/>
            <a:ext cx="28037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1-219-20219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57 kcal/m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D05072C-0EB4-2A72-90E7-8E6813A13F90}"/>
              </a:ext>
            </a:extLst>
          </p:cNvPr>
          <p:cNvSpPr txBox="1"/>
          <p:nvPr/>
        </p:nvSpPr>
        <p:spPr>
          <a:xfrm>
            <a:off x="7805252" y="6132901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324-19253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62 kcal/mol</a:t>
            </a:r>
          </a:p>
        </p:txBody>
      </p:sp>
    </p:spTree>
    <p:extLst>
      <p:ext uri="{BB962C8B-B14F-4D97-AF65-F5344CB8AC3E}">
        <p14:creationId xmlns:p14="http://schemas.microsoft.com/office/powerpoint/2010/main" val="292827846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9EEC29D-F399-101D-200C-21301645F08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oup of pills connected to each other&#10;&#10;AI-generated content may be incorrect.">
            <a:extLst>
              <a:ext uri="{FF2B5EF4-FFF2-40B4-BE49-F238E27FC236}">
                <a16:creationId xmlns:a16="http://schemas.microsoft.com/office/drawing/2014/main" id="{6FEA4FE8-1E20-CB47-CE70-8C6D04B644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65328" y="208625"/>
            <a:ext cx="12357328" cy="6528089"/>
          </a:xfrm>
          <a:prstGeom prst="rect">
            <a:avLst/>
          </a:prstGeom>
        </p:spPr>
      </p:pic>
      <p:sp>
        <p:nvSpPr>
          <p:cNvPr id="11" name="Title 1">
            <a:extLst>
              <a:ext uri="{FF2B5EF4-FFF2-40B4-BE49-F238E27FC236}">
                <a16:creationId xmlns:a16="http://schemas.microsoft.com/office/drawing/2014/main" id="{3081DFF2-6E61-B248-62C4-963060FF61F8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5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73730D2-CFB9-D96D-9E16-A5A816756C5E}"/>
              </a:ext>
            </a:extLst>
          </p:cNvPr>
          <p:cNvSpPr txBox="1"/>
          <p:nvPr/>
        </p:nvSpPr>
        <p:spPr>
          <a:xfrm>
            <a:off x="1200671" y="3118533"/>
            <a:ext cx="36408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Charged-1-388-10918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64 kcal/mo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966F4DB-1BEF-0DCD-3B43-0AB0431EDBBD}"/>
              </a:ext>
            </a:extLst>
          </p:cNvPr>
          <p:cNvSpPr txBox="1"/>
          <p:nvPr/>
        </p:nvSpPr>
        <p:spPr>
          <a:xfrm>
            <a:off x="4964979" y="3118531"/>
            <a:ext cx="26802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1-42-20230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67 kcal/m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B1CDAAA-C83F-181B-3AE5-0026AB3BC1FC}"/>
              </a:ext>
            </a:extLst>
          </p:cNvPr>
          <p:cNvSpPr txBox="1"/>
          <p:nvPr/>
        </p:nvSpPr>
        <p:spPr>
          <a:xfrm>
            <a:off x="7805252" y="3118531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586-15940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71 kcal/mo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07AA048-54A9-AD87-50BD-BC31F74A5599}"/>
              </a:ext>
            </a:extLst>
          </p:cNvPr>
          <p:cNvSpPr txBox="1"/>
          <p:nvPr/>
        </p:nvSpPr>
        <p:spPr>
          <a:xfrm>
            <a:off x="1200671" y="6211669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179-20852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74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E13480D-7DB0-5F27-837C-4F069E77D249}"/>
              </a:ext>
            </a:extLst>
          </p:cNvPr>
          <p:cNvSpPr txBox="1"/>
          <p:nvPr/>
        </p:nvSpPr>
        <p:spPr>
          <a:xfrm>
            <a:off x="4100429" y="6211666"/>
            <a:ext cx="37504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dirty="0"/>
              <a:t>20K-Charged-1-223-20222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79 kcal/m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DD61174-CFF7-2F90-82F9-ADE00DA28EEB}"/>
              </a:ext>
            </a:extLst>
          </p:cNvPr>
          <p:cNvSpPr txBox="1"/>
          <p:nvPr/>
        </p:nvSpPr>
        <p:spPr>
          <a:xfrm>
            <a:off x="7805252" y="6211667"/>
            <a:ext cx="347358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Charged-378-2036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81 kcal/mol</a:t>
            </a:r>
          </a:p>
        </p:txBody>
      </p:sp>
    </p:spTree>
    <p:extLst>
      <p:ext uri="{BB962C8B-B14F-4D97-AF65-F5344CB8AC3E}">
        <p14:creationId xmlns:p14="http://schemas.microsoft.com/office/powerpoint/2010/main" val="3865253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C322034-85C8-2C50-63CA-27961DE3105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molecular structures&#10;&#10;AI-generated content may be incorrect.">
            <a:extLst>
              <a:ext uri="{FF2B5EF4-FFF2-40B4-BE49-F238E27FC236}">
                <a16:creationId xmlns:a16="http://schemas.microsoft.com/office/drawing/2014/main" id="{E790D396-D94E-8115-AA0E-94BA7D7CAB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30146" y="208625"/>
            <a:ext cx="12586917" cy="6649375"/>
          </a:xfrm>
          <a:prstGeom prst="rect">
            <a:avLst/>
          </a:prstGeom>
        </p:spPr>
      </p:pic>
      <p:sp>
        <p:nvSpPr>
          <p:cNvPr id="11" name="Title 1">
            <a:extLst>
              <a:ext uri="{FF2B5EF4-FFF2-40B4-BE49-F238E27FC236}">
                <a16:creationId xmlns:a16="http://schemas.microsoft.com/office/drawing/2014/main" id="{CCDE541B-1AA8-4ADD-2172-21953C768696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5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3C465B7-5214-0685-2CF9-391FCF381B28}"/>
              </a:ext>
            </a:extLst>
          </p:cNvPr>
          <p:cNvSpPr txBox="1"/>
          <p:nvPr/>
        </p:nvSpPr>
        <p:spPr>
          <a:xfrm>
            <a:off x="1200671" y="3118533"/>
            <a:ext cx="36408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Charged-1-264-1831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83 kcal/mo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A0C77FC-0ADB-100F-5A74-BF950AB599E6}"/>
              </a:ext>
            </a:extLst>
          </p:cNvPr>
          <p:cNvSpPr txBox="1"/>
          <p:nvPr/>
        </p:nvSpPr>
        <p:spPr>
          <a:xfrm>
            <a:off x="4853756" y="3105834"/>
            <a:ext cx="26191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406-20495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83 kcal/m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8328F70-5A19-EF17-BE0E-4EB4F1396E4E}"/>
              </a:ext>
            </a:extLst>
          </p:cNvPr>
          <p:cNvSpPr txBox="1"/>
          <p:nvPr/>
        </p:nvSpPr>
        <p:spPr>
          <a:xfrm>
            <a:off x="7805252" y="3118531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279-1649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86 kcal/mo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25CD80D-8725-B0A1-D1B5-D26EE1029479}"/>
              </a:ext>
            </a:extLst>
          </p:cNvPr>
          <p:cNvSpPr txBox="1"/>
          <p:nvPr/>
        </p:nvSpPr>
        <p:spPr>
          <a:xfrm>
            <a:off x="1200671" y="6129211"/>
            <a:ext cx="26993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193-19858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89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6EC165B-C53E-A6D2-683C-D93DD13EA607}"/>
              </a:ext>
            </a:extLst>
          </p:cNvPr>
          <p:cNvSpPr txBox="1"/>
          <p:nvPr/>
        </p:nvSpPr>
        <p:spPr>
          <a:xfrm>
            <a:off x="4632598" y="6158509"/>
            <a:ext cx="28402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dirty="0"/>
              <a:t>20K-1-511-19050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90 kcal/m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48C2B43-AFB1-5D89-9159-E39DB0C4A13B}"/>
              </a:ext>
            </a:extLst>
          </p:cNvPr>
          <p:cNvSpPr txBox="1"/>
          <p:nvPr/>
        </p:nvSpPr>
        <p:spPr>
          <a:xfrm>
            <a:off x="7805252" y="6129209"/>
            <a:ext cx="34562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Charged-390-12970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91 kcal/mol</a:t>
            </a:r>
          </a:p>
        </p:txBody>
      </p:sp>
    </p:spTree>
    <p:extLst>
      <p:ext uri="{BB962C8B-B14F-4D97-AF65-F5344CB8AC3E}">
        <p14:creationId xmlns:p14="http://schemas.microsoft.com/office/powerpoint/2010/main" val="320686458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714241E-523B-33AA-D4CF-5BD1A796CE7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oup of molecular structures&#10;&#10;AI-generated content may be incorrect.">
            <a:extLst>
              <a:ext uri="{FF2B5EF4-FFF2-40B4-BE49-F238E27FC236}">
                <a16:creationId xmlns:a16="http://schemas.microsoft.com/office/drawing/2014/main" id="{4EB3181F-53EA-DAF8-A520-0164B82785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09476" y="208625"/>
            <a:ext cx="12610951" cy="6662072"/>
          </a:xfrm>
          <a:prstGeom prst="rect">
            <a:avLst/>
          </a:prstGeom>
        </p:spPr>
      </p:pic>
      <p:sp>
        <p:nvSpPr>
          <p:cNvPr id="11" name="Title 1">
            <a:extLst>
              <a:ext uri="{FF2B5EF4-FFF2-40B4-BE49-F238E27FC236}">
                <a16:creationId xmlns:a16="http://schemas.microsoft.com/office/drawing/2014/main" id="{FAE9FC5F-3563-F1F5-EE9C-E66BABE760FE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5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9A34877-E18F-E9BF-6CEF-592470CCDE36}"/>
              </a:ext>
            </a:extLst>
          </p:cNvPr>
          <p:cNvSpPr txBox="1"/>
          <p:nvPr/>
        </p:nvSpPr>
        <p:spPr>
          <a:xfrm>
            <a:off x="108389" y="3307543"/>
            <a:ext cx="27341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242-20161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92 kcal/mo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FE488FC-71E5-B0C4-DA7B-405EF0689721}"/>
              </a:ext>
            </a:extLst>
          </p:cNvPr>
          <p:cNvSpPr txBox="1"/>
          <p:nvPr/>
        </p:nvSpPr>
        <p:spPr>
          <a:xfrm>
            <a:off x="3468195" y="3269444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210-18967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92 kcal/m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3AC925D-1711-73A0-3110-C3243D550976}"/>
              </a:ext>
            </a:extLst>
          </p:cNvPr>
          <p:cNvSpPr txBox="1"/>
          <p:nvPr/>
        </p:nvSpPr>
        <p:spPr>
          <a:xfrm>
            <a:off x="6712970" y="3307541"/>
            <a:ext cx="27863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1-301-18862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96 kcal/mo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3DC9020-7FE7-B745-995E-40B9254DF7A8}"/>
              </a:ext>
            </a:extLst>
          </p:cNvPr>
          <p:cNvSpPr txBox="1"/>
          <p:nvPr/>
        </p:nvSpPr>
        <p:spPr>
          <a:xfrm>
            <a:off x="9533032" y="3294844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576-11420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99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83B4164-1B74-50E6-5B1A-DB7FA6BEFE7D}"/>
              </a:ext>
            </a:extLst>
          </p:cNvPr>
          <p:cNvSpPr txBox="1"/>
          <p:nvPr/>
        </p:nvSpPr>
        <p:spPr>
          <a:xfrm>
            <a:off x="96109" y="6224368"/>
            <a:ext cx="36581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Charged-1-422-20472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05 kcal/m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16AB024-2FB1-A50A-1FB3-15940B3885EB}"/>
              </a:ext>
            </a:extLst>
          </p:cNvPr>
          <p:cNvSpPr txBox="1"/>
          <p:nvPr/>
        </p:nvSpPr>
        <p:spPr>
          <a:xfrm>
            <a:off x="3651541" y="6211669"/>
            <a:ext cx="36581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dirty="0"/>
              <a:t>20K-Charged-1-397-9313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06 kcal/m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118D3C9-EF38-A40B-ACEA-7D7013D21A6C}"/>
              </a:ext>
            </a:extLst>
          </p:cNvPr>
          <p:cNvSpPr txBox="1"/>
          <p:nvPr/>
        </p:nvSpPr>
        <p:spPr>
          <a:xfrm>
            <a:off x="7022823" y="6224366"/>
            <a:ext cx="26629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1-44-16629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07 kcal/m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3A6E933-F7B9-F5E8-2795-80ED80B02B94}"/>
              </a:ext>
            </a:extLst>
          </p:cNvPr>
          <p:cNvSpPr txBox="1"/>
          <p:nvPr/>
        </p:nvSpPr>
        <p:spPr>
          <a:xfrm>
            <a:off x="9520752" y="6211669"/>
            <a:ext cx="26993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154-1163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09 kcal/mol</a:t>
            </a:r>
          </a:p>
        </p:txBody>
      </p:sp>
    </p:spTree>
    <p:extLst>
      <p:ext uri="{BB962C8B-B14F-4D97-AF65-F5344CB8AC3E}">
        <p14:creationId xmlns:p14="http://schemas.microsoft.com/office/powerpoint/2010/main" val="204957401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F330ADC-2534-BAE6-0180-428ABD7B2AE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B995B8F-7791-BE21-EB46-693234963C95}"/>
              </a:ext>
            </a:extLst>
          </p:cNvPr>
          <p:cNvSpPr txBox="1"/>
          <p:nvPr/>
        </p:nvSpPr>
        <p:spPr>
          <a:xfrm>
            <a:off x="188773" y="2980782"/>
            <a:ext cx="24872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0-15349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00 kcal/m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B6AE705-5074-EE3B-4F6B-DD0DA6D1787F}"/>
              </a:ext>
            </a:extLst>
          </p:cNvPr>
          <p:cNvSpPr txBox="1"/>
          <p:nvPr/>
        </p:nvSpPr>
        <p:spPr>
          <a:xfrm>
            <a:off x="9286458" y="2980782"/>
            <a:ext cx="25321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829-17962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68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1F1AF69-025B-8FB6-6A35-A904018C9908}"/>
              </a:ext>
            </a:extLst>
          </p:cNvPr>
          <p:cNvSpPr txBox="1"/>
          <p:nvPr/>
        </p:nvSpPr>
        <p:spPr>
          <a:xfrm>
            <a:off x="7237301" y="6211669"/>
            <a:ext cx="24534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14-18769-wb97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03 kcal/m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5D054B2-CDEA-8D77-7F7C-A751AF649D19}"/>
              </a:ext>
            </a:extLst>
          </p:cNvPr>
          <p:cNvSpPr txBox="1"/>
          <p:nvPr/>
        </p:nvSpPr>
        <p:spPr>
          <a:xfrm>
            <a:off x="4648546" y="2980782"/>
            <a:ext cx="26993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132-19847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49 kcal/mol</a:t>
            </a: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6453AB8F-4B4C-CE94-4024-ABB249DF98B0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6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9CFB3D2-ED29-D58D-FE07-6158B03B1570}"/>
              </a:ext>
            </a:extLst>
          </p:cNvPr>
          <p:cNvSpPr txBox="1"/>
          <p:nvPr/>
        </p:nvSpPr>
        <p:spPr>
          <a:xfrm>
            <a:off x="2501270" y="6211669"/>
            <a:ext cx="257596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19-15682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93 kcal/mol</a:t>
            </a:r>
          </a:p>
        </p:txBody>
      </p:sp>
      <p:pic>
        <p:nvPicPr>
          <p:cNvPr id="13" name="Picture 12" descr="A group of pills falling&#10;&#10;AI-generated content may be incorrect.">
            <a:extLst>
              <a:ext uri="{FF2B5EF4-FFF2-40B4-BE49-F238E27FC236}">
                <a16:creationId xmlns:a16="http://schemas.microsoft.com/office/drawing/2014/main" id="{83775D8F-97AC-50B8-2A96-FC2034A1F55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3904" t="4495" r="34094" b="15163"/>
          <a:stretch>
            <a:fillRect/>
          </a:stretch>
        </p:blipFill>
        <p:spPr>
          <a:xfrm>
            <a:off x="9627171" y="228355"/>
            <a:ext cx="1726629" cy="2709290"/>
          </a:xfrm>
          <a:prstGeom prst="rect">
            <a:avLst/>
          </a:prstGeom>
        </p:spPr>
      </p:pic>
      <p:pic>
        <p:nvPicPr>
          <p:cNvPr id="17" name="Picture 16" descr="A group of pills on a white background&#10;&#10;AI-generated content may be incorrect.">
            <a:extLst>
              <a:ext uri="{FF2B5EF4-FFF2-40B4-BE49-F238E27FC236}">
                <a16:creationId xmlns:a16="http://schemas.microsoft.com/office/drawing/2014/main" id="{3FD8530C-2B9D-8906-5743-250CCB4F94F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6587" t="32596" r="26017" b="23482"/>
          <a:stretch>
            <a:fillRect/>
          </a:stretch>
        </p:blipFill>
        <p:spPr>
          <a:xfrm>
            <a:off x="6868742" y="4012725"/>
            <a:ext cx="3683800" cy="2133592"/>
          </a:xfrm>
          <a:prstGeom prst="rect">
            <a:avLst/>
          </a:prstGeom>
        </p:spPr>
      </p:pic>
      <p:pic>
        <p:nvPicPr>
          <p:cNvPr id="19" name="Picture 18" descr="A close-up of a molecule&#10;&#10;AI-generated content may be incorrect.">
            <a:extLst>
              <a:ext uri="{FF2B5EF4-FFF2-40B4-BE49-F238E27FC236}">
                <a16:creationId xmlns:a16="http://schemas.microsoft.com/office/drawing/2014/main" id="{4EC9DABA-F40F-BEAD-B0C1-B12F6D7ED4B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6587" t="26128" r="32865" b="25333"/>
          <a:stretch>
            <a:fillRect/>
          </a:stretch>
        </p:blipFill>
        <p:spPr>
          <a:xfrm>
            <a:off x="2213482" y="3788446"/>
            <a:ext cx="3151537" cy="2357871"/>
          </a:xfrm>
          <a:prstGeom prst="rect">
            <a:avLst/>
          </a:prstGeom>
        </p:spPr>
      </p:pic>
      <p:pic>
        <p:nvPicPr>
          <p:cNvPr id="21" name="Picture 20" descr="A group of pills flying&#10;&#10;AI-generated content may be incorrect.">
            <a:extLst>
              <a:ext uri="{FF2B5EF4-FFF2-40B4-BE49-F238E27FC236}">
                <a16:creationId xmlns:a16="http://schemas.microsoft.com/office/drawing/2014/main" id="{D778D57D-40A0-038F-2A51-0CD5BFD589C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1840" t="17440" r="29412" b="24681"/>
          <a:stretch>
            <a:fillRect/>
          </a:stretch>
        </p:blipFill>
        <p:spPr>
          <a:xfrm>
            <a:off x="4793017" y="604449"/>
            <a:ext cx="2410450" cy="2250400"/>
          </a:xfrm>
          <a:prstGeom prst="rect">
            <a:avLst/>
          </a:prstGeom>
        </p:spPr>
      </p:pic>
      <p:pic>
        <p:nvPicPr>
          <p:cNvPr id="23" name="Picture 22" descr="A group of pills floating in the air&#10;&#10;AI-generated content may be incorrect.">
            <a:extLst>
              <a:ext uri="{FF2B5EF4-FFF2-40B4-BE49-F238E27FC236}">
                <a16:creationId xmlns:a16="http://schemas.microsoft.com/office/drawing/2014/main" id="{D017E4E7-8547-0993-8E43-5091557C98F3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33421" t="24724" r="29412" b="12906"/>
          <a:stretch>
            <a:fillRect/>
          </a:stretch>
        </p:blipFill>
        <p:spPr>
          <a:xfrm>
            <a:off x="495515" y="1015504"/>
            <a:ext cx="1873800" cy="19652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071441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3F2E9C6-09CF-3B9A-F3AB-6B3F349509C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C268B84-7F05-F65A-0EF0-89C80BF0E33B}"/>
              </a:ext>
            </a:extLst>
          </p:cNvPr>
          <p:cNvSpPr txBox="1"/>
          <p:nvPr/>
        </p:nvSpPr>
        <p:spPr>
          <a:xfrm>
            <a:off x="257012" y="5254388"/>
            <a:ext cx="25933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34-17483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00 kcal/m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26D3C69-BCD4-6908-A1E3-9BE7A0175822}"/>
              </a:ext>
            </a:extLst>
          </p:cNvPr>
          <p:cNvSpPr txBox="1"/>
          <p:nvPr/>
        </p:nvSpPr>
        <p:spPr>
          <a:xfrm>
            <a:off x="8906616" y="5272922"/>
            <a:ext cx="26993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126-12119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07 kcal/m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0C23E9-2B7A-3317-9A83-3AE7BD8A0F88}"/>
              </a:ext>
            </a:extLst>
          </p:cNvPr>
          <p:cNvSpPr txBox="1"/>
          <p:nvPr/>
        </p:nvSpPr>
        <p:spPr>
          <a:xfrm>
            <a:off x="4716785" y="5254388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601-18531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24 kcal/mol</a:t>
            </a: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28907A88-ECFA-A1C2-CAFA-2BBB02404F3F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7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pic>
        <p:nvPicPr>
          <p:cNvPr id="8" name="Picture 7" descr="A group of pills falling&#10;&#10;AI-generated content may be incorrect.">
            <a:extLst>
              <a:ext uri="{FF2B5EF4-FFF2-40B4-BE49-F238E27FC236}">
                <a16:creationId xmlns:a16="http://schemas.microsoft.com/office/drawing/2014/main" id="{306CE0F1-EE3F-2804-D738-ABB16D2DDDE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9624" t="15067" r="28819" b="25674"/>
          <a:stretch>
            <a:fillRect/>
          </a:stretch>
        </p:blipFill>
        <p:spPr>
          <a:xfrm>
            <a:off x="5029589" y="261509"/>
            <a:ext cx="1902109" cy="2217042"/>
          </a:xfrm>
          <a:prstGeom prst="rect">
            <a:avLst/>
          </a:prstGeom>
        </p:spPr>
      </p:pic>
      <p:pic>
        <p:nvPicPr>
          <p:cNvPr id="14" name="Picture 13" descr="A group of pills on a white background&#10;&#10;AI-generated content may be incorrect.">
            <a:extLst>
              <a:ext uri="{FF2B5EF4-FFF2-40B4-BE49-F238E27FC236}">
                <a16:creationId xmlns:a16="http://schemas.microsoft.com/office/drawing/2014/main" id="{FEF2A5E4-17A4-AD5E-76CC-E8B8E62D391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4260" t="26967" r="32544" b="26320"/>
          <a:stretch>
            <a:fillRect/>
          </a:stretch>
        </p:blipFill>
        <p:spPr>
          <a:xfrm>
            <a:off x="9130239" y="343876"/>
            <a:ext cx="2252145" cy="2014113"/>
          </a:xfrm>
          <a:prstGeom prst="rect">
            <a:avLst/>
          </a:prstGeom>
        </p:spPr>
      </p:pic>
      <p:pic>
        <p:nvPicPr>
          <p:cNvPr id="3" name="Picture 2" descr="A white and red pills&#10;&#10;AI-generated content may be incorrect.">
            <a:extLst>
              <a:ext uri="{FF2B5EF4-FFF2-40B4-BE49-F238E27FC236}">
                <a16:creationId xmlns:a16="http://schemas.microsoft.com/office/drawing/2014/main" id="{12889D93-C530-D98A-23DA-5E3568B52E9F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0882" t="17323" r="25840" b="7843"/>
          <a:stretch>
            <a:fillRect/>
          </a:stretch>
        </p:blipFill>
        <p:spPr>
          <a:xfrm>
            <a:off x="8906616" y="2478551"/>
            <a:ext cx="2971318" cy="2673809"/>
          </a:xfrm>
          <a:prstGeom prst="rect">
            <a:avLst/>
          </a:prstGeom>
        </p:spPr>
      </p:pic>
      <p:pic>
        <p:nvPicPr>
          <p:cNvPr id="9" name="Picture 8" descr="A molecule of pills&#10;&#10;AI-generated content may be incorrect.">
            <a:extLst>
              <a:ext uri="{FF2B5EF4-FFF2-40B4-BE49-F238E27FC236}">
                <a16:creationId xmlns:a16="http://schemas.microsoft.com/office/drawing/2014/main" id="{3B3A0DF8-CAE3-D8C4-0506-E6250D8CF198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28782" t="14600" r="28151" b="9452"/>
          <a:stretch>
            <a:fillRect/>
          </a:stretch>
        </p:blipFill>
        <p:spPr>
          <a:xfrm>
            <a:off x="4523844" y="2515264"/>
            <a:ext cx="2913599" cy="2673810"/>
          </a:xfrm>
          <a:prstGeom prst="rect">
            <a:avLst/>
          </a:prstGeom>
        </p:spPr>
      </p:pic>
      <p:pic>
        <p:nvPicPr>
          <p:cNvPr id="13" name="Picture 12" descr="A molecule model of a molecule&#10;&#10;AI-generated content may be incorrect.">
            <a:extLst>
              <a:ext uri="{FF2B5EF4-FFF2-40B4-BE49-F238E27FC236}">
                <a16:creationId xmlns:a16="http://schemas.microsoft.com/office/drawing/2014/main" id="{414C2E29-D549-352B-CF5F-C4BDAF047D64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27310" t="16216" r="25000" b="3827"/>
          <a:stretch>
            <a:fillRect/>
          </a:stretch>
        </p:blipFill>
        <p:spPr>
          <a:xfrm>
            <a:off x="0" y="1713877"/>
            <a:ext cx="3931363" cy="34302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949268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17FAA94-62B2-1909-50E4-7A5098331D3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 descr="A group of pills connected to each other&#10;&#10;AI-generated content may be incorrect.">
            <a:extLst>
              <a:ext uri="{FF2B5EF4-FFF2-40B4-BE49-F238E27FC236}">
                <a16:creationId xmlns:a16="http://schemas.microsoft.com/office/drawing/2014/main" id="{CBAE0D24-25F3-2DF0-4CFB-4905B4AE190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5448" r="14076"/>
          <a:stretch>
            <a:fillRect/>
          </a:stretch>
        </p:blipFill>
        <p:spPr>
          <a:xfrm>
            <a:off x="1458544" y="142330"/>
            <a:ext cx="8940047" cy="6601367"/>
          </a:xfrm>
          <a:prstGeom prst="rect">
            <a:avLst/>
          </a:prstGeom>
        </p:spPr>
      </p:pic>
      <p:sp>
        <p:nvSpPr>
          <p:cNvPr id="11" name="Title 1">
            <a:extLst>
              <a:ext uri="{FF2B5EF4-FFF2-40B4-BE49-F238E27FC236}">
                <a16:creationId xmlns:a16="http://schemas.microsoft.com/office/drawing/2014/main" id="{691A6982-C753-FFC0-B3D2-E568C826FC9C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8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6D34730-77F9-F9C5-ED8B-BF50BD80811E}"/>
              </a:ext>
            </a:extLst>
          </p:cNvPr>
          <p:cNvSpPr txBox="1"/>
          <p:nvPr/>
        </p:nvSpPr>
        <p:spPr>
          <a:xfrm>
            <a:off x="1200671" y="3118533"/>
            <a:ext cx="25846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119-7838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00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7E80925-807C-E7CE-62A0-006A0EA67FC7}"/>
              </a:ext>
            </a:extLst>
          </p:cNvPr>
          <p:cNvSpPr txBox="1"/>
          <p:nvPr/>
        </p:nvSpPr>
        <p:spPr>
          <a:xfrm>
            <a:off x="4964979" y="3118531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112-20883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22 kcal/m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50379EB-F536-0455-BB04-64FB00536D10}"/>
              </a:ext>
            </a:extLst>
          </p:cNvPr>
          <p:cNvSpPr txBox="1"/>
          <p:nvPr/>
        </p:nvSpPr>
        <p:spPr>
          <a:xfrm>
            <a:off x="7805252" y="3118531"/>
            <a:ext cx="27863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1-204-18088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36 kcal/m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1DCB355-4E19-38A0-6AE5-5C62D4CBF0B3}"/>
              </a:ext>
            </a:extLst>
          </p:cNvPr>
          <p:cNvSpPr txBox="1"/>
          <p:nvPr/>
        </p:nvSpPr>
        <p:spPr>
          <a:xfrm>
            <a:off x="1200671" y="6211669"/>
            <a:ext cx="254954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490-20893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38 kcal/mo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FAEFA76-BB0D-5AEC-556C-9F073CDAAC91}"/>
              </a:ext>
            </a:extLst>
          </p:cNvPr>
          <p:cNvSpPr txBox="1"/>
          <p:nvPr/>
        </p:nvSpPr>
        <p:spPr>
          <a:xfrm>
            <a:off x="4100429" y="6211666"/>
            <a:ext cx="37504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dirty="0"/>
              <a:t>20K-34-14676-wb97x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38 kcal/mo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4B6A8A3-1A07-751F-61BD-4ED61A71FE33}"/>
              </a:ext>
            </a:extLst>
          </p:cNvPr>
          <p:cNvSpPr txBox="1"/>
          <p:nvPr/>
        </p:nvSpPr>
        <p:spPr>
          <a:xfrm>
            <a:off x="7805252" y="6211667"/>
            <a:ext cx="25933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45-1067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41 kcal/mol</a:t>
            </a:r>
          </a:p>
        </p:txBody>
      </p:sp>
    </p:spTree>
    <p:extLst>
      <p:ext uri="{BB962C8B-B14F-4D97-AF65-F5344CB8AC3E}">
        <p14:creationId xmlns:p14="http://schemas.microsoft.com/office/powerpoint/2010/main" val="193628742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ECF56C1-2748-15EC-D41A-BF71DCDA1FA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oup of molecular structures&#10;&#10;AI-generated content may be incorrect.">
            <a:extLst>
              <a:ext uri="{FF2B5EF4-FFF2-40B4-BE49-F238E27FC236}">
                <a16:creationId xmlns:a16="http://schemas.microsoft.com/office/drawing/2014/main" id="{6811D4C2-179B-B666-AAE5-2A83F56C105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2606" r="11555"/>
          <a:stretch>
            <a:fillRect/>
          </a:stretch>
        </p:blipFill>
        <p:spPr>
          <a:xfrm>
            <a:off x="1438470" y="316478"/>
            <a:ext cx="8678527" cy="5955032"/>
          </a:xfrm>
          <a:prstGeom prst="rect">
            <a:avLst/>
          </a:prstGeom>
        </p:spPr>
      </p:pic>
      <p:sp>
        <p:nvSpPr>
          <p:cNvPr id="11" name="Title 1">
            <a:extLst>
              <a:ext uri="{FF2B5EF4-FFF2-40B4-BE49-F238E27FC236}">
                <a16:creationId xmlns:a16="http://schemas.microsoft.com/office/drawing/2014/main" id="{57B722D2-1ED8-DE9A-43DD-6306A06DCAF7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8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EB607B1-FA79-A37E-B561-A6DF6B0F1A32}"/>
              </a:ext>
            </a:extLst>
          </p:cNvPr>
          <p:cNvSpPr txBox="1"/>
          <p:nvPr/>
        </p:nvSpPr>
        <p:spPr>
          <a:xfrm>
            <a:off x="1200671" y="3118533"/>
            <a:ext cx="25933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59-14612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50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6936D59-F3D6-97F8-EA1B-490D0A34AD00}"/>
              </a:ext>
            </a:extLst>
          </p:cNvPr>
          <p:cNvSpPr txBox="1"/>
          <p:nvPr/>
        </p:nvSpPr>
        <p:spPr>
          <a:xfrm>
            <a:off x="4964979" y="3118531"/>
            <a:ext cx="26107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81-20265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57 kcal/m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F56DB5-D797-6119-E150-D823ABDAA73E}"/>
              </a:ext>
            </a:extLst>
          </p:cNvPr>
          <p:cNvSpPr txBox="1"/>
          <p:nvPr/>
        </p:nvSpPr>
        <p:spPr>
          <a:xfrm>
            <a:off x="7805252" y="3118531"/>
            <a:ext cx="27863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1-318-19136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58 kcal/m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D4282F6-8910-3340-A27A-465599874DE5}"/>
              </a:ext>
            </a:extLst>
          </p:cNvPr>
          <p:cNvSpPr txBox="1"/>
          <p:nvPr/>
        </p:nvSpPr>
        <p:spPr>
          <a:xfrm>
            <a:off x="1200671" y="6211669"/>
            <a:ext cx="27863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1-208-18937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61 kcal/mo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6506D84-E394-1593-B502-0CDF3C8E9F37}"/>
              </a:ext>
            </a:extLst>
          </p:cNvPr>
          <p:cNvSpPr txBox="1"/>
          <p:nvPr/>
        </p:nvSpPr>
        <p:spPr>
          <a:xfrm>
            <a:off x="4395132" y="6211666"/>
            <a:ext cx="37504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dirty="0"/>
              <a:t>20K-1-304-17679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63 kcal/mo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2322B2A-94E0-6909-32B3-983999161BBF}"/>
              </a:ext>
            </a:extLst>
          </p:cNvPr>
          <p:cNvSpPr txBox="1"/>
          <p:nvPr/>
        </p:nvSpPr>
        <p:spPr>
          <a:xfrm>
            <a:off x="7805252" y="6211667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502-1787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81 kcal/mol</a:t>
            </a:r>
          </a:p>
        </p:txBody>
      </p:sp>
    </p:spTree>
    <p:extLst>
      <p:ext uri="{BB962C8B-B14F-4D97-AF65-F5344CB8AC3E}">
        <p14:creationId xmlns:p14="http://schemas.microsoft.com/office/powerpoint/2010/main" val="307280026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030BCC5-6E42-E592-3CF3-5D00630CBE9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pills connected together&#10;&#10;AI-generated content may be incorrect.">
            <a:extLst>
              <a:ext uri="{FF2B5EF4-FFF2-40B4-BE49-F238E27FC236}">
                <a16:creationId xmlns:a16="http://schemas.microsoft.com/office/drawing/2014/main" id="{EB5C14E1-1680-15E5-0ACB-B0E517F005B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7984" r="8824"/>
          <a:stretch>
            <a:fillRect/>
          </a:stretch>
        </p:blipFill>
        <p:spPr>
          <a:xfrm>
            <a:off x="1235795" y="606604"/>
            <a:ext cx="9127672" cy="5709659"/>
          </a:xfrm>
          <a:prstGeom prst="rect">
            <a:avLst/>
          </a:prstGeom>
        </p:spPr>
      </p:pic>
      <p:sp>
        <p:nvSpPr>
          <p:cNvPr id="11" name="Title 1">
            <a:extLst>
              <a:ext uri="{FF2B5EF4-FFF2-40B4-BE49-F238E27FC236}">
                <a16:creationId xmlns:a16="http://schemas.microsoft.com/office/drawing/2014/main" id="{046B9E4C-2AA7-ABC8-57CF-2B6636EEFE9F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8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5F7C89F-BAAC-D8D3-2D6D-DC7AFE96EF09}"/>
              </a:ext>
            </a:extLst>
          </p:cNvPr>
          <p:cNvSpPr txBox="1"/>
          <p:nvPr/>
        </p:nvSpPr>
        <p:spPr>
          <a:xfrm>
            <a:off x="1200671" y="3118533"/>
            <a:ext cx="24786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42-7309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70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4845A4A-E998-E9F5-8C0C-6A984B7CF178}"/>
              </a:ext>
            </a:extLst>
          </p:cNvPr>
          <p:cNvSpPr txBox="1"/>
          <p:nvPr/>
        </p:nvSpPr>
        <p:spPr>
          <a:xfrm>
            <a:off x="4964979" y="3118531"/>
            <a:ext cx="27689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1-141-1962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70 kcal/m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AA3D2A2-6D57-9382-36D0-41C1493D0A72}"/>
              </a:ext>
            </a:extLst>
          </p:cNvPr>
          <p:cNvSpPr txBox="1"/>
          <p:nvPr/>
        </p:nvSpPr>
        <p:spPr>
          <a:xfrm>
            <a:off x="7805252" y="3118531"/>
            <a:ext cx="27341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369-20795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77 kcal/m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2FDEB69-7047-DA01-77B2-7AA9DEE1CBCF}"/>
              </a:ext>
            </a:extLst>
          </p:cNvPr>
          <p:cNvSpPr txBox="1"/>
          <p:nvPr/>
        </p:nvSpPr>
        <p:spPr>
          <a:xfrm>
            <a:off x="1200671" y="6211669"/>
            <a:ext cx="24534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73-17249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86 kcal/mo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4036C23-4A17-1106-55D6-D07AB1C7014F}"/>
              </a:ext>
            </a:extLst>
          </p:cNvPr>
          <p:cNvSpPr txBox="1"/>
          <p:nvPr/>
        </p:nvSpPr>
        <p:spPr>
          <a:xfrm>
            <a:off x="4395132" y="6211666"/>
            <a:ext cx="37504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dirty="0"/>
              <a:t>20K-1-100-20187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92 kcal/mo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1E163E3-8973-8DB1-9AAE-3E1E6130D606}"/>
              </a:ext>
            </a:extLst>
          </p:cNvPr>
          <p:cNvSpPr txBox="1"/>
          <p:nvPr/>
        </p:nvSpPr>
        <p:spPr>
          <a:xfrm>
            <a:off x="7805252" y="6211667"/>
            <a:ext cx="260173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342-16375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92 kcal/mol</a:t>
            </a:r>
          </a:p>
        </p:txBody>
      </p:sp>
    </p:spTree>
    <p:extLst>
      <p:ext uri="{BB962C8B-B14F-4D97-AF65-F5344CB8AC3E}">
        <p14:creationId xmlns:p14="http://schemas.microsoft.com/office/powerpoint/2010/main" val="226319566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B5337DA-C4D9-75F4-6FD4-736C1E5BC31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oup of molecular structures&#10;&#10;AI-generated content may be incorrect.">
            <a:extLst>
              <a:ext uri="{FF2B5EF4-FFF2-40B4-BE49-F238E27FC236}">
                <a16:creationId xmlns:a16="http://schemas.microsoft.com/office/drawing/2014/main" id="{2E3678FE-015F-FC15-F6B6-EDE6F734C2B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0785" r="10084"/>
          <a:stretch>
            <a:fillRect/>
          </a:stretch>
        </p:blipFill>
        <p:spPr>
          <a:xfrm>
            <a:off x="953362" y="121286"/>
            <a:ext cx="10037967" cy="6601367"/>
          </a:xfrm>
          <a:prstGeom prst="rect">
            <a:avLst/>
          </a:prstGeom>
        </p:spPr>
      </p:pic>
      <p:sp>
        <p:nvSpPr>
          <p:cNvPr id="11" name="Title 1">
            <a:extLst>
              <a:ext uri="{FF2B5EF4-FFF2-40B4-BE49-F238E27FC236}">
                <a16:creationId xmlns:a16="http://schemas.microsoft.com/office/drawing/2014/main" id="{D247EDC6-A56B-BDC5-680A-71A0B78FCFB4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8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8F01740-62B4-7B36-EF66-081F140E6A3A}"/>
              </a:ext>
            </a:extLst>
          </p:cNvPr>
          <p:cNvSpPr txBox="1"/>
          <p:nvPr/>
        </p:nvSpPr>
        <p:spPr>
          <a:xfrm>
            <a:off x="1200671" y="3118533"/>
            <a:ext cx="247830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80-1079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93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C5A8C98-4DB0-4563-633A-1754BD139B03}"/>
              </a:ext>
            </a:extLst>
          </p:cNvPr>
          <p:cNvSpPr txBox="1"/>
          <p:nvPr/>
        </p:nvSpPr>
        <p:spPr>
          <a:xfrm>
            <a:off x="4964979" y="3118531"/>
            <a:ext cx="26107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281-8848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99 kcal/m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4BF66A2-4F55-2FBE-3528-1B6EADA46602}"/>
              </a:ext>
            </a:extLst>
          </p:cNvPr>
          <p:cNvSpPr txBox="1"/>
          <p:nvPr/>
        </p:nvSpPr>
        <p:spPr>
          <a:xfrm>
            <a:off x="7805252" y="3118531"/>
            <a:ext cx="257596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15-15922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05 kcal/m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6AD061F-6E0B-CDF8-3377-B6C3CD4FC5D3}"/>
              </a:ext>
            </a:extLst>
          </p:cNvPr>
          <p:cNvSpPr txBox="1"/>
          <p:nvPr/>
        </p:nvSpPr>
        <p:spPr>
          <a:xfrm>
            <a:off x="1200671" y="6211669"/>
            <a:ext cx="26993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133-1925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05 kcal/mo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7D0B6E6-48B7-DBF7-31B9-FA0877D08374}"/>
              </a:ext>
            </a:extLst>
          </p:cNvPr>
          <p:cNvSpPr txBox="1"/>
          <p:nvPr/>
        </p:nvSpPr>
        <p:spPr>
          <a:xfrm>
            <a:off x="4386749" y="6211666"/>
            <a:ext cx="37504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dirty="0"/>
              <a:t>20K-1-43-18087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06 kcal/mol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5BD1A14-F7E9-04EA-C2E6-953742A86AB6}"/>
              </a:ext>
            </a:extLst>
          </p:cNvPr>
          <p:cNvSpPr txBox="1"/>
          <p:nvPr/>
        </p:nvSpPr>
        <p:spPr>
          <a:xfrm>
            <a:off x="7805252" y="6211667"/>
            <a:ext cx="25933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149-932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10 kcal/mol</a:t>
            </a:r>
          </a:p>
        </p:txBody>
      </p:sp>
    </p:spTree>
    <p:extLst>
      <p:ext uri="{BB962C8B-B14F-4D97-AF65-F5344CB8AC3E}">
        <p14:creationId xmlns:p14="http://schemas.microsoft.com/office/powerpoint/2010/main" val="3204662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063525-1E1E-1202-6941-9B85302D02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21286"/>
            <a:ext cx="10515600" cy="725904"/>
          </a:xfrm>
        </p:spPr>
        <p:txBody>
          <a:bodyPr/>
          <a:lstStyle/>
          <a:p>
            <a:r>
              <a:rPr lang="en-US" dirty="0"/>
              <a:t>TFA-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pic>
        <p:nvPicPr>
          <p:cNvPr id="5" name="Picture 4" descr="A group of objects with different colors&#10;&#10;AI-generated content may be incorrect.">
            <a:extLst>
              <a:ext uri="{FF2B5EF4-FFF2-40B4-BE49-F238E27FC236}">
                <a16:creationId xmlns:a16="http://schemas.microsoft.com/office/drawing/2014/main" id="{913F2EDA-CC86-E79C-EA4B-30C843CB63F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7793" t="31546" r="25003" b="34069"/>
          <a:stretch>
            <a:fillRect/>
          </a:stretch>
        </p:blipFill>
        <p:spPr>
          <a:xfrm>
            <a:off x="3008851" y="1828800"/>
            <a:ext cx="6174297" cy="280416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4591C1F-AA06-503C-E913-60E9222D135B}"/>
              </a:ext>
            </a:extLst>
          </p:cNvPr>
          <p:cNvSpPr txBox="1"/>
          <p:nvPr/>
        </p:nvSpPr>
        <p:spPr>
          <a:xfrm>
            <a:off x="4678680" y="5120640"/>
            <a:ext cx="25568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M7-1-220-675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00 kcal/mol</a:t>
            </a:r>
          </a:p>
        </p:txBody>
      </p:sp>
      <p:pic>
        <p:nvPicPr>
          <p:cNvPr id="2052" name="Picture 4">
            <a:extLst>
              <a:ext uri="{FF2B5EF4-FFF2-40B4-BE49-F238E27FC236}">
                <a16:creationId xmlns:a16="http://schemas.microsoft.com/office/drawing/2014/main" id="{6887C2C8-682E-ED1A-FD23-6D4FD5C89A8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000" y="-411163"/>
            <a:ext cx="12700" cy="12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08971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 descr="A group of pills on a white background&#10;&#10;AI-generated content may be incorrect.">
            <a:extLst>
              <a:ext uri="{FF2B5EF4-FFF2-40B4-BE49-F238E27FC236}">
                <a16:creationId xmlns:a16="http://schemas.microsoft.com/office/drawing/2014/main" id="{329C31B1-8BE3-FE78-5AE6-261CEB4ACBF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rcRect l="22638" t="21087" r="23732" b="20073"/>
          <a:stretch>
            <a:fillRect/>
          </a:stretch>
        </p:blipFill>
        <p:spPr>
          <a:xfrm>
            <a:off x="609599" y="1690688"/>
            <a:ext cx="4179685" cy="2866071"/>
          </a:xfrm>
        </p:spPr>
      </p:pic>
      <p:pic>
        <p:nvPicPr>
          <p:cNvPr id="9" name="Picture 8" descr="A group of pills on a white background&#10;&#10;AI-generated content may be incorrect.">
            <a:extLst>
              <a:ext uri="{FF2B5EF4-FFF2-40B4-BE49-F238E27FC236}">
                <a16:creationId xmlns:a16="http://schemas.microsoft.com/office/drawing/2014/main" id="{425CDED8-0BE9-CEF9-EFAD-D3D93DD4FBD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3726" t="18196" r="23726" b="24078"/>
          <a:stretch>
            <a:fillRect/>
          </a:stretch>
        </p:blipFill>
        <p:spPr>
          <a:xfrm>
            <a:off x="6294119" y="1340168"/>
            <a:ext cx="4685035" cy="3216591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81D9475E-1A5F-C461-1E77-AF7B5495B528}"/>
              </a:ext>
            </a:extLst>
          </p:cNvPr>
          <p:cNvSpPr txBox="1"/>
          <p:nvPr/>
        </p:nvSpPr>
        <p:spPr>
          <a:xfrm>
            <a:off x="1421014" y="4597716"/>
            <a:ext cx="25147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00-16088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00 kcal/mo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EB22FF4-E28F-7C1F-D2D7-A48D1EF9A82E}"/>
              </a:ext>
            </a:extLst>
          </p:cNvPr>
          <p:cNvSpPr txBox="1"/>
          <p:nvPr/>
        </p:nvSpPr>
        <p:spPr>
          <a:xfrm>
            <a:off x="7278251" y="4597716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102-20183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21 kcal/mol</a:t>
            </a:r>
          </a:p>
        </p:txBody>
      </p:sp>
      <p:sp>
        <p:nvSpPr>
          <p:cNvPr id="15" name="Title 1">
            <a:extLst>
              <a:ext uri="{FF2B5EF4-FFF2-40B4-BE49-F238E27FC236}">
                <a16:creationId xmlns:a16="http://schemas.microsoft.com/office/drawing/2014/main" id="{32C6422C-48C2-FD92-115D-29387922C558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2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</p:spTree>
    <p:extLst>
      <p:ext uri="{BB962C8B-B14F-4D97-AF65-F5344CB8AC3E}">
        <p14:creationId xmlns:p14="http://schemas.microsoft.com/office/powerpoint/2010/main" val="37562505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20F9E46-71A9-51F0-A280-15B71E17157D}"/>
              </a:ext>
            </a:extLst>
          </p:cNvPr>
          <p:cNvSpPr txBox="1"/>
          <p:nvPr/>
        </p:nvSpPr>
        <p:spPr>
          <a:xfrm>
            <a:off x="838200" y="3105835"/>
            <a:ext cx="260173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M7-478-1870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00 kcal/m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6651B87-1A64-EF9A-CFBF-E8D68095AFCB}"/>
              </a:ext>
            </a:extLst>
          </p:cNvPr>
          <p:cNvSpPr txBox="1"/>
          <p:nvPr/>
        </p:nvSpPr>
        <p:spPr>
          <a:xfrm>
            <a:off x="4811141" y="3105833"/>
            <a:ext cx="24534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07-9863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06 kcal/mo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5FAA6F3-D60C-34AB-1A2D-20797330BCCB}"/>
              </a:ext>
            </a:extLst>
          </p:cNvPr>
          <p:cNvSpPr txBox="1"/>
          <p:nvPr/>
        </p:nvSpPr>
        <p:spPr>
          <a:xfrm>
            <a:off x="7264570" y="6017058"/>
            <a:ext cx="26993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100-11057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03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692FCE6-88DA-F002-4E1F-BD0BBE4A5C7F}"/>
              </a:ext>
            </a:extLst>
          </p:cNvPr>
          <p:cNvSpPr txBox="1"/>
          <p:nvPr/>
        </p:nvSpPr>
        <p:spPr>
          <a:xfrm>
            <a:off x="8889654" y="3105833"/>
            <a:ext cx="26993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156-1636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54 kcal/m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D549698-7587-09B3-3F05-6A44DC88862E}"/>
              </a:ext>
            </a:extLst>
          </p:cNvPr>
          <p:cNvSpPr txBox="1"/>
          <p:nvPr/>
        </p:nvSpPr>
        <p:spPr>
          <a:xfrm>
            <a:off x="2904017" y="6017058"/>
            <a:ext cx="26993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101-14638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07 kcal/mol</a:t>
            </a: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EC03FC5A-7450-FD72-CD30-DFAA2B1BCA7C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3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pic>
        <p:nvPicPr>
          <p:cNvPr id="15" name="Picture 14" descr="A group of pills in different colors&#10;&#10;AI-generated content may be incorrect.">
            <a:extLst>
              <a:ext uri="{FF2B5EF4-FFF2-40B4-BE49-F238E27FC236}">
                <a16:creationId xmlns:a16="http://schemas.microsoft.com/office/drawing/2014/main" id="{838197E3-657C-5D17-E664-5F17132E91D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1373" t="13804" r="23137" b="22760"/>
          <a:stretch>
            <a:fillRect/>
          </a:stretch>
        </p:blipFill>
        <p:spPr>
          <a:xfrm>
            <a:off x="629325" y="894669"/>
            <a:ext cx="3019487" cy="2157439"/>
          </a:xfrm>
          <a:prstGeom prst="rect">
            <a:avLst/>
          </a:prstGeom>
        </p:spPr>
      </p:pic>
      <p:pic>
        <p:nvPicPr>
          <p:cNvPr id="17" name="Picture 16" descr="A group of pills in different colors&#10;&#10;AI-generated content may be incorrect.">
            <a:extLst>
              <a:ext uri="{FF2B5EF4-FFF2-40B4-BE49-F238E27FC236}">
                <a16:creationId xmlns:a16="http://schemas.microsoft.com/office/drawing/2014/main" id="{19CF8A91-ABC9-1746-D856-428AD51E4CC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4510" t="17440" r="19803" b="14667"/>
          <a:stretch>
            <a:fillRect/>
          </a:stretch>
        </p:blipFill>
        <p:spPr>
          <a:xfrm>
            <a:off x="4619551" y="787093"/>
            <a:ext cx="3019488" cy="2300872"/>
          </a:xfrm>
          <a:prstGeom prst="rect">
            <a:avLst/>
          </a:prstGeom>
        </p:spPr>
      </p:pic>
      <p:pic>
        <p:nvPicPr>
          <p:cNvPr id="19" name="Picture 18" descr="A group of pills on a white background&#10;&#10;AI-generated content may be incorrect.">
            <a:extLst>
              <a:ext uri="{FF2B5EF4-FFF2-40B4-BE49-F238E27FC236}">
                <a16:creationId xmlns:a16="http://schemas.microsoft.com/office/drawing/2014/main" id="{D5EB5A9E-BFB6-49EB-B5DB-77C7F7AA77F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1177" t="16941" r="21177" b="23129"/>
          <a:stretch>
            <a:fillRect/>
          </a:stretch>
        </p:blipFill>
        <p:spPr>
          <a:xfrm>
            <a:off x="8707050" y="894669"/>
            <a:ext cx="3064602" cy="1991215"/>
          </a:xfrm>
          <a:prstGeom prst="rect">
            <a:avLst/>
          </a:prstGeom>
        </p:spPr>
      </p:pic>
      <p:pic>
        <p:nvPicPr>
          <p:cNvPr id="21" name="Picture 20" descr="A group of pills in different colors&#10;&#10;AI-generated content may be incorrect.">
            <a:extLst>
              <a:ext uri="{FF2B5EF4-FFF2-40B4-BE49-F238E27FC236}">
                <a16:creationId xmlns:a16="http://schemas.microsoft.com/office/drawing/2014/main" id="{FC41D718-A2A6-91B1-2504-259ACD646F7B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1765" t="22902" r="19019" b="29411"/>
          <a:stretch>
            <a:fillRect/>
          </a:stretch>
        </p:blipFill>
        <p:spPr>
          <a:xfrm>
            <a:off x="2631658" y="4073772"/>
            <a:ext cx="3464342" cy="1743642"/>
          </a:xfrm>
          <a:prstGeom prst="rect">
            <a:avLst/>
          </a:prstGeom>
        </p:spPr>
      </p:pic>
      <p:pic>
        <p:nvPicPr>
          <p:cNvPr id="23" name="Picture 22" descr="A group of pills in different colors&#10;&#10;AI-generated content may be incorrect.">
            <a:extLst>
              <a:ext uri="{FF2B5EF4-FFF2-40B4-BE49-F238E27FC236}">
                <a16:creationId xmlns:a16="http://schemas.microsoft.com/office/drawing/2014/main" id="{170938B5-03C9-70F2-FCB7-497E7661181A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20589" t="21421" r="20196" b="22759"/>
          <a:stretch>
            <a:fillRect/>
          </a:stretch>
        </p:blipFill>
        <p:spPr>
          <a:xfrm>
            <a:off x="7015954" y="4003938"/>
            <a:ext cx="3196624" cy="18833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67261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F0C073E-D698-74B7-5F46-3A470963545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887063B-A661-89B1-F5B7-117B13AC7321}"/>
              </a:ext>
            </a:extLst>
          </p:cNvPr>
          <p:cNvSpPr txBox="1"/>
          <p:nvPr/>
        </p:nvSpPr>
        <p:spPr>
          <a:xfrm>
            <a:off x="188773" y="2980782"/>
            <a:ext cx="24872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2-20618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00 kcal/m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32D4BFD-BDAD-E1A3-C917-3B74A4C4D150}"/>
              </a:ext>
            </a:extLst>
          </p:cNvPr>
          <p:cNvSpPr txBox="1"/>
          <p:nvPr/>
        </p:nvSpPr>
        <p:spPr>
          <a:xfrm>
            <a:off x="9286458" y="2980782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271-17480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29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61D7138-02B9-5D40-F041-D4D3D35A304A}"/>
              </a:ext>
            </a:extLst>
          </p:cNvPr>
          <p:cNvSpPr txBox="1"/>
          <p:nvPr/>
        </p:nvSpPr>
        <p:spPr>
          <a:xfrm>
            <a:off x="2356451" y="6211669"/>
            <a:ext cx="26191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M7-308-20583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33 kcal/m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13F58FB-8C76-1C19-0B68-3A8D7467AE7E}"/>
              </a:ext>
            </a:extLst>
          </p:cNvPr>
          <p:cNvSpPr txBox="1"/>
          <p:nvPr/>
        </p:nvSpPr>
        <p:spPr>
          <a:xfrm>
            <a:off x="4975566" y="2980782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219-19250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28 kcal/mol</a:t>
            </a: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861EAB37-5215-BE1F-21B1-2932F73DB00E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4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0AFBD7A-1D30-3835-6FDA-DC9BD41C7058}"/>
              </a:ext>
            </a:extLst>
          </p:cNvPr>
          <p:cNvSpPr txBox="1"/>
          <p:nvPr/>
        </p:nvSpPr>
        <p:spPr>
          <a:xfrm>
            <a:off x="7692335" y="6211669"/>
            <a:ext cx="25933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61-13552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38 kcal/mol</a:t>
            </a:r>
          </a:p>
        </p:txBody>
      </p:sp>
      <p:pic>
        <p:nvPicPr>
          <p:cNvPr id="13" name="Picture 12" descr="A group of pills in different colors&#10;&#10;AI-generated content may be incorrect.">
            <a:extLst>
              <a:ext uri="{FF2B5EF4-FFF2-40B4-BE49-F238E27FC236}">
                <a16:creationId xmlns:a16="http://schemas.microsoft.com/office/drawing/2014/main" id="{4E342537-1D24-BA8B-296F-432DAEF98F2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2549" t="17440" r="20392" b="4000"/>
          <a:stretch>
            <a:fillRect/>
          </a:stretch>
        </p:blipFill>
        <p:spPr>
          <a:xfrm>
            <a:off x="449435" y="888369"/>
            <a:ext cx="1965960" cy="2051234"/>
          </a:xfrm>
          <a:prstGeom prst="rect">
            <a:avLst/>
          </a:prstGeom>
        </p:spPr>
      </p:pic>
      <p:pic>
        <p:nvPicPr>
          <p:cNvPr id="16" name="Picture 15" descr="A group of pills on a white background&#10;&#10;AI-generated content may be incorrect.">
            <a:extLst>
              <a:ext uri="{FF2B5EF4-FFF2-40B4-BE49-F238E27FC236}">
                <a16:creationId xmlns:a16="http://schemas.microsoft.com/office/drawing/2014/main" id="{6ED62A21-1FE7-1BB5-81A6-2B46C6C9E1D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3467" t="22032" r="25356" b="5454"/>
          <a:stretch>
            <a:fillRect/>
          </a:stretch>
        </p:blipFill>
        <p:spPr>
          <a:xfrm>
            <a:off x="5350969" y="847188"/>
            <a:ext cx="1965961" cy="2163834"/>
          </a:xfrm>
          <a:prstGeom prst="rect">
            <a:avLst/>
          </a:prstGeom>
        </p:spPr>
      </p:pic>
      <p:pic>
        <p:nvPicPr>
          <p:cNvPr id="20" name="Picture 19" descr="A group of pills in different colors&#10;&#10;AI-generated content may be incorrect.">
            <a:extLst>
              <a:ext uri="{FF2B5EF4-FFF2-40B4-BE49-F238E27FC236}">
                <a16:creationId xmlns:a16="http://schemas.microsoft.com/office/drawing/2014/main" id="{24F3886B-7581-9E1C-19E7-55557DDC0DF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1417" t="24813" r="27095" b="8663"/>
          <a:stretch>
            <a:fillRect/>
          </a:stretch>
        </p:blipFill>
        <p:spPr>
          <a:xfrm>
            <a:off x="9473454" y="750429"/>
            <a:ext cx="2255749" cy="2260593"/>
          </a:xfrm>
          <a:prstGeom prst="rect">
            <a:avLst/>
          </a:prstGeom>
        </p:spPr>
      </p:pic>
      <p:pic>
        <p:nvPicPr>
          <p:cNvPr id="24" name="Picture 23" descr="A group of pills in a white background&#10;&#10;AI-generated content may be incorrect.">
            <a:extLst>
              <a:ext uri="{FF2B5EF4-FFF2-40B4-BE49-F238E27FC236}">
                <a16:creationId xmlns:a16="http://schemas.microsoft.com/office/drawing/2014/main" id="{09DE651E-E636-36B4-9832-177690E9826C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1418" t="18288" r="27948"/>
          <a:stretch>
            <a:fillRect/>
          </a:stretch>
        </p:blipFill>
        <p:spPr>
          <a:xfrm>
            <a:off x="2779750" y="3880537"/>
            <a:ext cx="1854785" cy="2331132"/>
          </a:xfrm>
          <a:prstGeom prst="rect">
            <a:avLst/>
          </a:prstGeom>
        </p:spPr>
      </p:pic>
      <p:pic>
        <p:nvPicPr>
          <p:cNvPr id="26" name="Picture 25" descr="A group of red and white objects&#10;&#10;AI-generated content may be incorrect.">
            <a:extLst>
              <a:ext uri="{FF2B5EF4-FFF2-40B4-BE49-F238E27FC236}">
                <a16:creationId xmlns:a16="http://schemas.microsoft.com/office/drawing/2014/main" id="{92750425-0098-6CB1-D750-D7EB2A160212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31417" t="26690" r="26368"/>
          <a:stretch>
            <a:fillRect/>
          </a:stretch>
        </p:blipFill>
        <p:spPr>
          <a:xfrm>
            <a:off x="7711963" y="3673362"/>
            <a:ext cx="2338653" cy="25383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62240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A908784-4E13-1227-7973-3D62CCB720F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7EEB6ED7-815B-C5D8-2B13-A4401827E79C}"/>
              </a:ext>
            </a:extLst>
          </p:cNvPr>
          <p:cNvSpPr txBox="1"/>
          <p:nvPr/>
        </p:nvSpPr>
        <p:spPr>
          <a:xfrm>
            <a:off x="0" y="3178531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522-18790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65 kcal/mol</a:t>
            </a: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C9F7BD5D-4510-8E7F-B029-5F75BBD53565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4H</a:t>
            </a:r>
            <a:r>
              <a:rPr lang="en-US" baseline="-25000" dirty="0"/>
              <a:t>2</a:t>
            </a:r>
            <a:r>
              <a:rPr lang="en-US" dirty="0"/>
              <a:t>O continue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C5B0266-4A93-2EAD-3F5F-D1D6AFF094D3}"/>
              </a:ext>
            </a:extLst>
          </p:cNvPr>
          <p:cNvSpPr txBox="1"/>
          <p:nvPr/>
        </p:nvSpPr>
        <p:spPr>
          <a:xfrm>
            <a:off x="7563935" y="3148050"/>
            <a:ext cx="26993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192-16583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85 kcal/mo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B6B04CF-0C80-3D0F-F3C6-7050B5A8AEB7}"/>
              </a:ext>
            </a:extLst>
          </p:cNvPr>
          <p:cNvSpPr txBox="1"/>
          <p:nvPr/>
        </p:nvSpPr>
        <p:spPr>
          <a:xfrm>
            <a:off x="2095897" y="6247643"/>
            <a:ext cx="24872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986-231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86 kcal/mo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8CED77C-02A7-951A-614E-0B9BA85D4562}"/>
              </a:ext>
            </a:extLst>
          </p:cNvPr>
          <p:cNvSpPr txBox="1"/>
          <p:nvPr/>
        </p:nvSpPr>
        <p:spPr>
          <a:xfrm>
            <a:off x="3651362" y="3191389"/>
            <a:ext cx="26107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589-9225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83 kcal/m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79868A1-7BFC-7695-F5AA-3C8D67DED02A}"/>
              </a:ext>
            </a:extLst>
          </p:cNvPr>
          <p:cNvSpPr txBox="1"/>
          <p:nvPr/>
        </p:nvSpPr>
        <p:spPr>
          <a:xfrm>
            <a:off x="9659832" y="6217163"/>
            <a:ext cx="25321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303-15737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07 kcal/m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21346F7-1923-7F23-72BB-4A68DAA708CA}"/>
              </a:ext>
            </a:extLst>
          </p:cNvPr>
          <p:cNvSpPr txBox="1"/>
          <p:nvPr/>
        </p:nvSpPr>
        <p:spPr>
          <a:xfrm>
            <a:off x="6057298" y="6247643"/>
            <a:ext cx="260205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K-1-331-7562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1.06 kcal/mol</a:t>
            </a:r>
          </a:p>
        </p:txBody>
      </p:sp>
      <p:pic>
        <p:nvPicPr>
          <p:cNvPr id="15" name="Picture 14" descr="A group of pills on a white background&#10;&#10;AI-generated content may be incorrect.">
            <a:extLst>
              <a:ext uri="{FF2B5EF4-FFF2-40B4-BE49-F238E27FC236}">
                <a16:creationId xmlns:a16="http://schemas.microsoft.com/office/drawing/2014/main" id="{F631D9B8-6120-6D23-2157-A3A8A7EAABF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5879" t="25566" r="24613" b="20772"/>
          <a:stretch>
            <a:fillRect/>
          </a:stretch>
        </p:blipFill>
        <p:spPr>
          <a:xfrm>
            <a:off x="90575" y="818146"/>
            <a:ext cx="2707054" cy="2297988"/>
          </a:xfrm>
          <a:prstGeom prst="rect">
            <a:avLst/>
          </a:prstGeom>
        </p:spPr>
      </p:pic>
      <p:pic>
        <p:nvPicPr>
          <p:cNvPr id="17" name="Picture 16" descr="A group of pills on a white background&#10;&#10;AI-generated content may be incorrect.">
            <a:extLst>
              <a:ext uri="{FF2B5EF4-FFF2-40B4-BE49-F238E27FC236}">
                <a16:creationId xmlns:a16="http://schemas.microsoft.com/office/drawing/2014/main" id="{6CC5093E-7284-A74E-C2F4-A9364EDCEFD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9994" t="21352" r="29412" b="17401"/>
          <a:stretch>
            <a:fillRect/>
          </a:stretch>
        </p:blipFill>
        <p:spPr>
          <a:xfrm>
            <a:off x="3690985" y="866782"/>
            <a:ext cx="2472421" cy="2331454"/>
          </a:xfrm>
          <a:prstGeom prst="rect">
            <a:avLst/>
          </a:prstGeom>
        </p:spPr>
      </p:pic>
      <p:pic>
        <p:nvPicPr>
          <p:cNvPr id="19" name="Picture 18" descr="A group of pills on a white background&#10;&#10;AI-generated content may be incorrect.">
            <a:extLst>
              <a:ext uri="{FF2B5EF4-FFF2-40B4-BE49-F238E27FC236}">
                <a16:creationId xmlns:a16="http://schemas.microsoft.com/office/drawing/2014/main" id="{71890510-E4CC-0E5A-6C12-7F9327C5CA8B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0965" t="20229" r="25290" b="13187"/>
          <a:stretch>
            <a:fillRect/>
          </a:stretch>
        </p:blipFill>
        <p:spPr>
          <a:xfrm>
            <a:off x="7604811" y="667453"/>
            <a:ext cx="2617639" cy="2490153"/>
          </a:xfrm>
          <a:prstGeom prst="rect">
            <a:avLst/>
          </a:prstGeom>
        </p:spPr>
      </p:pic>
      <p:pic>
        <p:nvPicPr>
          <p:cNvPr id="21" name="Picture 20" descr="A group of pills on a white background&#10;&#10;AI-generated content may be incorrect.">
            <a:extLst>
              <a:ext uri="{FF2B5EF4-FFF2-40B4-BE49-F238E27FC236}">
                <a16:creationId xmlns:a16="http://schemas.microsoft.com/office/drawing/2014/main" id="{3FAD9A07-38B7-46CA-0EFB-BD373E2A073A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2745" t="19947" r="25290" b="12200"/>
          <a:stretch>
            <a:fillRect/>
          </a:stretch>
        </p:blipFill>
        <p:spPr>
          <a:xfrm>
            <a:off x="2179660" y="3903444"/>
            <a:ext cx="2319758" cy="2344199"/>
          </a:xfrm>
          <a:prstGeom prst="rect">
            <a:avLst/>
          </a:prstGeom>
        </p:spPr>
      </p:pic>
      <p:pic>
        <p:nvPicPr>
          <p:cNvPr id="23" name="Picture 22" descr="A group of pills on a white background&#10;&#10;AI-generated content may be incorrect.">
            <a:extLst>
              <a:ext uri="{FF2B5EF4-FFF2-40B4-BE49-F238E27FC236}">
                <a16:creationId xmlns:a16="http://schemas.microsoft.com/office/drawing/2014/main" id="{4A02610F-49D0-1669-69FF-B71AB33B5A3D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33247" t="22195" r="24520" b="16839"/>
          <a:stretch>
            <a:fillRect/>
          </a:stretch>
        </p:blipFill>
        <p:spPr>
          <a:xfrm>
            <a:off x="6057298" y="3814128"/>
            <a:ext cx="2610716" cy="2355467"/>
          </a:xfrm>
          <a:prstGeom prst="rect">
            <a:avLst/>
          </a:prstGeom>
        </p:spPr>
      </p:pic>
      <p:pic>
        <p:nvPicPr>
          <p:cNvPr id="25" name="Picture 24" descr="A group of pills on a white background&#10;&#10;AI-generated content may be incorrect.">
            <a:extLst>
              <a:ext uri="{FF2B5EF4-FFF2-40B4-BE49-F238E27FC236}">
                <a16:creationId xmlns:a16="http://schemas.microsoft.com/office/drawing/2014/main" id="{812D28B2-7EE0-B6C0-A3C6-B1EBCD5E6DB3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33247" t="22195" r="29412" b="12201"/>
          <a:stretch>
            <a:fillRect/>
          </a:stretch>
        </p:blipFill>
        <p:spPr>
          <a:xfrm>
            <a:off x="9593950" y="3700394"/>
            <a:ext cx="2319758" cy="25472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91926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A3C78E2-6771-96C2-A763-788185388BE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oup of pills connected to each other&#10;&#10;AI-generated content may be incorrect.">
            <a:extLst>
              <a:ext uri="{FF2B5EF4-FFF2-40B4-BE49-F238E27FC236}">
                <a16:creationId xmlns:a16="http://schemas.microsoft.com/office/drawing/2014/main" id="{9859FF49-B848-E169-B5DE-2493572EC3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4191" y="174171"/>
            <a:ext cx="11617810" cy="6137419"/>
          </a:xfrm>
          <a:prstGeom prst="rect">
            <a:avLst/>
          </a:prstGeom>
        </p:spPr>
      </p:pic>
      <p:sp>
        <p:nvSpPr>
          <p:cNvPr id="11" name="Title 1">
            <a:extLst>
              <a:ext uri="{FF2B5EF4-FFF2-40B4-BE49-F238E27FC236}">
                <a16:creationId xmlns:a16="http://schemas.microsoft.com/office/drawing/2014/main" id="{EC31F1D4-593F-0A80-911F-DAEB6B48FB8F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5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116B731-B9CD-883D-E09A-E177AC3D4BE9}"/>
              </a:ext>
            </a:extLst>
          </p:cNvPr>
          <p:cNvSpPr txBox="1"/>
          <p:nvPr/>
        </p:nvSpPr>
        <p:spPr>
          <a:xfrm>
            <a:off x="1682496" y="2782669"/>
            <a:ext cx="24534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0-12610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00 kcal/m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E8559A6-DC51-5CEE-9FBF-42F80944A782}"/>
              </a:ext>
            </a:extLst>
          </p:cNvPr>
          <p:cNvSpPr txBox="1"/>
          <p:nvPr/>
        </p:nvSpPr>
        <p:spPr>
          <a:xfrm>
            <a:off x="5213096" y="2782668"/>
            <a:ext cx="24534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07-519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07 kcal/mo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D8FA202-EE79-B313-3866-FEA94483D08A}"/>
              </a:ext>
            </a:extLst>
          </p:cNvPr>
          <p:cNvSpPr txBox="1"/>
          <p:nvPr/>
        </p:nvSpPr>
        <p:spPr>
          <a:xfrm>
            <a:off x="8510821" y="3022102"/>
            <a:ext cx="25933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186-388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17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A81E894-B57B-D957-3EB3-267CF5F27527}"/>
              </a:ext>
            </a:extLst>
          </p:cNvPr>
          <p:cNvSpPr txBox="1"/>
          <p:nvPr/>
        </p:nvSpPr>
        <p:spPr>
          <a:xfrm>
            <a:off x="1682496" y="5868769"/>
            <a:ext cx="25321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276-19512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18 kcal/m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32705A7-AFF5-EF57-D270-A863021BD395}"/>
              </a:ext>
            </a:extLst>
          </p:cNvPr>
          <p:cNvSpPr txBox="1"/>
          <p:nvPr/>
        </p:nvSpPr>
        <p:spPr>
          <a:xfrm>
            <a:off x="5213096" y="5970359"/>
            <a:ext cx="26455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1-17-18703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27 kcal/m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37F7377-941D-C219-68A7-74CD9F98512D}"/>
              </a:ext>
            </a:extLst>
          </p:cNvPr>
          <p:cNvSpPr txBox="1"/>
          <p:nvPr/>
        </p:nvSpPr>
        <p:spPr>
          <a:xfrm>
            <a:off x="8287271" y="6071948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986-15365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28 kcal/mol</a:t>
            </a:r>
          </a:p>
        </p:txBody>
      </p:sp>
    </p:spTree>
    <p:extLst>
      <p:ext uri="{BB962C8B-B14F-4D97-AF65-F5344CB8AC3E}">
        <p14:creationId xmlns:p14="http://schemas.microsoft.com/office/powerpoint/2010/main" val="9709141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90BD3B3-3134-A02C-663A-6D144CEF265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molecular structures&#10;&#10;AI-generated content may be incorrect.">
            <a:extLst>
              <a:ext uri="{FF2B5EF4-FFF2-40B4-BE49-F238E27FC236}">
                <a16:creationId xmlns:a16="http://schemas.microsoft.com/office/drawing/2014/main" id="{61E1E27B-B104-89EB-F807-592266C54C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04742"/>
            <a:ext cx="12084808" cy="6384123"/>
          </a:xfrm>
          <a:prstGeom prst="rect">
            <a:avLst/>
          </a:prstGeom>
        </p:spPr>
      </p:pic>
      <p:sp>
        <p:nvSpPr>
          <p:cNvPr id="11" name="Title 1">
            <a:extLst>
              <a:ext uri="{FF2B5EF4-FFF2-40B4-BE49-F238E27FC236}">
                <a16:creationId xmlns:a16="http://schemas.microsoft.com/office/drawing/2014/main" id="{F83CD104-C79C-A738-2DB5-E9FEE43B7A4A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5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21B5631-E2F1-D671-4619-AE744ACC1CA1}"/>
              </a:ext>
            </a:extLst>
          </p:cNvPr>
          <p:cNvSpPr txBox="1"/>
          <p:nvPr/>
        </p:nvSpPr>
        <p:spPr>
          <a:xfrm>
            <a:off x="1200671" y="3016933"/>
            <a:ext cx="36581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Charged-1-361-20187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31 kcal/mo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28FE169-8EC0-57DE-E3C6-BE8845344E2C}"/>
              </a:ext>
            </a:extLst>
          </p:cNvPr>
          <p:cNvSpPr txBox="1"/>
          <p:nvPr/>
        </p:nvSpPr>
        <p:spPr>
          <a:xfrm>
            <a:off x="4858852" y="3016932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921-13085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31 kcal/m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C2AAFC3-E447-AE82-FED0-6F52A4BAC8D9}"/>
              </a:ext>
            </a:extLst>
          </p:cNvPr>
          <p:cNvSpPr txBox="1"/>
          <p:nvPr/>
        </p:nvSpPr>
        <p:spPr>
          <a:xfrm>
            <a:off x="7805252" y="3016931"/>
            <a:ext cx="25321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851-13570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31 kcal/mo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EBE2DA1-7363-3D8C-666C-DF80CE2E4341}"/>
              </a:ext>
            </a:extLst>
          </p:cNvPr>
          <p:cNvSpPr txBox="1"/>
          <p:nvPr/>
        </p:nvSpPr>
        <p:spPr>
          <a:xfrm>
            <a:off x="1200671" y="5946419"/>
            <a:ext cx="26802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1-40-20705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32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F0A3172-9AC7-2FBF-FB8F-670C08A3DFA4}"/>
              </a:ext>
            </a:extLst>
          </p:cNvPr>
          <p:cNvSpPr txBox="1"/>
          <p:nvPr/>
        </p:nvSpPr>
        <p:spPr>
          <a:xfrm>
            <a:off x="4858852" y="5946418"/>
            <a:ext cx="25321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318-19852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34 kcal/m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E05471-549D-07B2-EBF8-1E997FFCC25D}"/>
              </a:ext>
            </a:extLst>
          </p:cNvPr>
          <p:cNvSpPr txBox="1"/>
          <p:nvPr/>
        </p:nvSpPr>
        <p:spPr>
          <a:xfrm>
            <a:off x="7805252" y="5946417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515-16014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35 kcal/mol</a:t>
            </a:r>
          </a:p>
        </p:txBody>
      </p:sp>
    </p:spTree>
    <p:extLst>
      <p:ext uri="{BB962C8B-B14F-4D97-AF65-F5344CB8AC3E}">
        <p14:creationId xmlns:p14="http://schemas.microsoft.com/office/powerpoint/2010/main" val="15723653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328FDA7-9B6E-6EE1-D819-488E301637A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oup of pills connected to each other&#10;&#10;AI-generated content may be incorrect.">
            <a:extLst>
              <a:ext uri="{FF2B5EF4-FFF2-40B4-BE49-F238E27FC236}">
                <a16:creationId xmlns:a16="http://schemas.microsoft.com/office/drawing/2014/main" id="{5C61C285-43AC-5C0E-9257-2192587454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08625"/>
            <a:ext cx="11974766" cy="6325990"/>
          </a:xfrm>
          <a:prstGeom prst="rect">
            <a:avLst/>
          </a:prstGeom>
        </p:spPr>
      </p:pic>
      <p:sp>
        <p:nvSpPr>
          <p:cNvPr id="11" name="Title 1">
            <a:extLst>
              <a:ext uri="{FF2B5EF4-FFF2-40B4-BE49-F238E27FC236}">
                <a16:creationId xmlns:a16="http://schemas.microsoft.com/office/drawing/2014/main" id="{8548A38E-25F0-6CB2-2C07-67065802500C}"/>
              </a:ext>
            </a:extLst>
          </p:cNvPr>
          <p:cNvSpPr txBox="1">
            <a:spLocks/>
          </p:cNvSpPr>
          <p:nvPr/>
        </p:nvSpPr>
        <p:spPr>
          <a:xfrm>
            <a:off x="838200" y="121286"/>
            <a:ext cx="10515600" cy="7259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TFA-5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6A51386-1ECF-1F70-EA99-B153F6CEA1E8}"/>
              </a:ext>
            </a:extLst>
          </p:cNvPr>
          <p:cNvSpPr txBox="1"/>
          <p:nvPr/>
        </p:nvSpPr>
        <p:spPr>
          <a:xfrm>
            <a:off x="1200671" y="3016933"/>
            <a:ext cx="27863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1-126-20507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35 kcal/mo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4C3C980-BB5C-919E-B829-50E7E42E9A13}"/>
              </a:ext>
            </a:extLst>
          </p:cNvPr>
          <p:cNvSpPr txBox="1"/>
          <p:nvPr/>
        </p:nvSpPr>
        <p:spPr>
          <a:xfrm>
            <a:off x="4858852" y="2744194"/>
            <a:ext cx="247830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64-17881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37 kcal/mo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8E8C692-1539-6CB8-DDA0-4A4958373AE1}"/>
              </a:ext>
            </a:extLst>
          </p:cNvPr>
          <p:cNvSpPr txBox="1"/>
          <p:nvPr/>
        </p:nvSpPr>
        <p:spPr>
          <a:xfrm>
            <a:off x="7805252" y="3016931"/>
            <a:ext cx="27863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1-320-18281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41 kcal/m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D48D23F-8A95-63D7-83CD-642087830512}"/>
              </a:ext>
            </a:extLst>
          </p:cNvPr>
          <p:cNvSpPr txBox="1"/>
          <p:nvPr/>
        </p:nvSpPr>
        <p:spPr>
          <a:xfrm>
            <a:off x="1200671" y="6051908"/>
            <a:ext cx="2716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1-208-11981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42 kcal/m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8BF7EC0-3203-7395-4114-CD79499FC7D0}"/>
              </a:ext>
            </a:extLst>
          </p:cNvPr>
          <p:cNvSpPr txBox="1"/>
          <p:nvPr/>
        </p:nvSpPr>
        <p:spPr>
          <a:xfrm>
            <a:off x="4916320" y="6003044"/>
            <a:ext cx="2888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PM7-1-977-18823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43 kcal/m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A6E1577-DF06-449E-7FF1-9EF03DBD853F}"/>
              </a:ext>
            </a:extLst>
          </p:cNvPr>
          <p:cNvSpPr txBox="1"/>
          <p:nvPr/>
        </p:nvSpPr>
        <p:spPr>
          <a:xfrm>
            <a:off x="7805252" y="6051906"/>
            <a:ext cx="25321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dirty="0"/>
              <a:t>20K-305-19370-wb97xd</a:t>
            </a:r>
          </a:p>
          <a:p>
            <a:r>
              <a:rPr lang="en-US" altLang="en-US" dirty="0"/>
              <a:t>Δ</a:t>
            </a:r>
            <a:r>
              <a:rPr lang="en-US" dirty="0"/>
              <a:t>E(0 K) = 0.45 kcal/mol</a:t>
            </a:r>
          </a:p>
        </p:txBody>
      </p:sp>
    </p:spTree>
    <p:extLst>
      <p:ext uri="{BB962C8B-B14F-4D97-AF65-F5344CB8AC3E}">
        <p14:creationId xmlns:p14="http://schemas.microsoft.com/office/powerpoint/2010/main" val="17672045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3</TotalTime>
  <Words>1143</Words>
  <Application>Microsoft Macintosh PowerPoint</Application>
  <PresentationFormat>Widescreen</PresentationFormat>
  <Paragraphs>221</Paragraphs>
  <Slides>19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4" baseType="lpstr">
      <vt:lpstr>Aptos</vt:lpstr>
      <vt:lpstr>Aptos Display</vt:lpstr>
      <vt:lpstr>Arial</vt:lpstr>
      <vt:lpstr>Symbol</vt:lpstr>
      <vt:lpstr>Office Theme</vt:lpstr>
      <vt:lpstr>PowerPoint Presentation</vt:lpstr>
      <vt:lpstr>TFA-H2O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roline Glick</dc:creator>
  <cp:lastModifiedBy>Caroline Glick</cp:lastModifiedBy>
  <cp:revision>8</cp:revision>
  <dcterms:created xsi:type="dcterms:W3CDTF">2025-11-17T15:22:18Z</dcterms:created>
  <dcterms:modified xsi:type="dcterms:W3CDTF">2025-12-01T19:41:32Z</dcterms:modified>
</cp:coreProperties>
</file>